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6" r:id="rId3"/>
    <p:sldId id="257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56"/>
  </p:normalViewPr>
  <p:slideViewPr>
    <p:cSldViewPr snapToGrid="0" snapToObjects="1">
      <p:cViewPr varScale="1">
        <p:scale>
          <a:sx n="112" d="100"/>
          <a:sy n="112" d="100"/>
        </p:scale>
        <p:origin x="5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02A816-2AC9-7244-8340-46C27AEDC7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5828709-CB23-684F-8576-40B4ABA7C7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3C99B8-F43F-D84C-BBA9-C27CB7CE6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91B4A6-AFE2-3E43-AC1F-40592074F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BC1DFC-DAD9-7F4F-95C2-0F7B2A1AB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520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C98459-BDDA-0A44-BF05-83D42730BC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F57651-4DC5-3441-9153-9DAD1B7C8C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90AF4A-E783-9944-8392-827D6B47B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835B6A-B017-454B-82BB-9FC7AEE98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C6CD1E-603B-A248-987D-98F8BE240E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8867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C2DFD6-AB20-3A48-928F-71682A629B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3D25A1-A04B-6B45-8C07-D07932E5C3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BD01BC-7A68-154C-959D-30E405D4D9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1A4494-4228-E743-AB44-750795DAA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8A14A0-8BC5-D54F-BFDA-6A12586F08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949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833A0F-585C-854A-BA37-94DF67CDA3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812DEEB-1951-D043-9655-FDD42D0644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E1B3C0-0EF7-7F4B-A7A3-B3ED9FC7F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AE5F64-2967-F94E-B29B-CFB558A711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98FAE6-D08A-C545-8A5D-F3D3B8CFE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691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B21F8E-C8C8-E24D-BA1C-02187EAFE4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438429-AE20-114F-85CB-70244CFBC6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91560E-9621-404F-A8CD-81DA53196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EF4F38-9E74-084C-B3E2-4908EAAFD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681C02-54B5-FF49-B2B1-753301ABF4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651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6932CB-3547-384D-BB16-E5DC3E707F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6A648D-23F2-204C-867C-45AEF4EB14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C93DF8-F91B-FF4C-9BFB-24E92BB7C5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EFC60E-0D79-F34A-96FF-5A176C582F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889AFB-2A9D-AB44-B964-E4EFADA63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72FE98-2142-1848-B076-3C106103B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845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118F54-BA20-0E47-9070-0E06CAC605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F14B23-9055-174E-BBA3-9E44C37E48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4CD16E-E247-A747-923C-03250FDDFD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FAFD3B5-2CDC-7E46-8932-10350F1CA0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32006D1-C251-6749-838F-8C104BD827A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20C73A0-A665-5C4F-B718-ABB56B28F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AA9816-15C6-A94E-BE2F-C9774E613C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2CB742-9840-7D4E-8A76-5286819B5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563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73FCAE-C908-EB4D-95BE-2AC9ECD8CA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16D552F-AA10-0345-8C78-034CAEFCE0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FDECB01-4082-8549-9870-3C72E14D8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5190C7-359D-5148-B007-6DC019CA09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820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B682CC2-2B34-FC4E-A359-8B6D7615E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648D2C-71B3-4548-9BA5-69D76F00B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6ACC9B-9E68-5B4C-A3D9-5B2DF4AA3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6710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4E6D9F-3F71-8D4D-AC0D-EEC945BE6D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AB4289-212B-EE47-8757-8563E1138D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346FC3-7F66-A241-A3AA-9D8E7F23E2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14AEA5-06BD-284D-BE44-A14AF4843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73451D-2B4A-1547-A2FB-53DC50ED4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AAAEEB-40FE-4346-8970-7E2E32AB4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3955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7A128F-A550-7746-A679-40ED9F3A98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7B075A-F5C9-3F42-9E3C-71C50BC769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B3DF4F-20E7-D243-B314-9B384AEE9D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79C840-F109-D347-A0E7-20BE3EBBA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CF7BDA-BDC8-0E42-9C35-CB7CC9712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9C3E00-C8B2-324A-A904-62B3D624E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561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2612AB-EAFB-3047-8EDB-C7FCAF5B32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F4F8E6-60AF-DF4C-94CA-383F15B25E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18C1C0-932A-CB48-9B08-FA346E767A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E4DEC0-3A4C-0745-A7E6-F628FDA8C2D4}" type="datetimeFigureOut">
              <a:rPr lang="en-US" smtClean="0"/>
              <a:t>12/18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C63E84-5013-6D43-B9BF-1AD2E0D58E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9EF96D-B893-C042-8A91-07D21A3ACD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05CF84-DBBD-9047-BCC6-B42A675518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68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A025DC44-174F-7D40-8126-69CBD4A40F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9100" y="1498600"/>
            <a:ext cx="3733800" cy="38608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03F9A03-2D17-7B4F-9D48-F315051D2793}"/>
              </a:ext>
            </a:extLst>
          </p:cNvPr>
          <p:cNvSpPr txBox="1"/>
          <p:nvPr/>
        </p:nvSpPr>
        <p:spPr>
          <a:xfrm>
            <a:off x="1282535" y="381940"/>
            <a:ext cx="15031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S2A</a:t>
            </a:r>
          </a:p>
        </p:txBody>
      </p:sp>
    </p:spTree>
    <p:extLst>
      <p:ext uri="{BB962C8B-B14F-4D97-AF65-F5344CB8AC3E}">
        <p14:creationId xmlns:p14="http://schemas.microsoft.com/office/powerpoint/2010/main" val="1025921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4221902-EC63-5E4D-8426-17E1547D9E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6642759" y="1381990"/>
            <a:ext cx="1890838" cy="325414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E35D321-92D7-1346-9F07-76D869B0BD5E}"/>
              </a:ext>
            </a:extLst>
          </p:cNvPr>
          <p:cNvSpPr txBox="1"/>
          <p:nvPr/>
        </p:nvSpPr>
        <p:spPr>
          <a:xfrm>
            <a:off x="764401" y="338359"/>
            <a:ext cx="2979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S2A Right panel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1DF586F-231E-1147-B424-DBB586FFDC2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2999"/>
          <a:stretch/>
        </p:blipFill>
        <p:spPr>
          <a:xfrm>
            <a:off x="310242" y="1510476"/>
            <a:ext cx="4124757" cy="2004620"/>
          </a:xfrm>
          <a:prstGeom prst="rect">
            <a:avLst/>
          </a:prstGeom>
        </p:spPr>
      </p:pic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1E53D48A-066B-C047-B4C2-E90A8FA5D2F2}"/>
              </a:ext>
            </a:extLst>
          </p:cNvPr>
          <p:cNvCxnSpPr>
            <a:cxnSpLocks/>
          </p:cNvCxnSpPr>
          <p:nvPr/>
        </p:nvCxnSpPr>
        <p:spPr>
          <a:xfrm>
            <a:off x="4191990" y="2695699"/>
            <a:ext cx="165067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96706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D8DB2FD-6FBB-A840-B543-89B65216C4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5986559" y="-601249"/>
            <a:ext cx="4051846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E288496-A99B-F147-ADE1-34877758BE5A}"/>
              </a:ext>
            </a:extLst>
          </p:cNvPr>
          <p:cNvSpPr txBox="1"/>
          <p:nvPr/>
        </p:nvSpPr>
        <p:spPr>
          <a:xfrm>
            <a:off x="718681" y="109759"/>
            <a:ext cx="2755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S2A left panel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0451FB4-AA1E-3449-9F20-44BE64FC6D3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53614"/>
          <a:stretch/>
        </p:blipFill>
        <p:spPr>
          <a:xfrm>
            <a:off x="678378" y="1451098"/>
            <a:ext cx="3733800" cy="1790866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0D9A55EA-0135-9C47-A0D7-CD715C6FE912}"/>
              </a:ext>
            </a:extLst>
          </p:cNvPr>
          <p:cNvCxnSpPr>
            <a:cxnSpLocks/>
          </p:cNvCxnSpPr>
          <p:nvPr/>
        </p:nvCxnSpPr>
        <p:spPr>
          <a:xfrm>
            <a:off x="2396104" y="2827750"/>
            <a:ext cx="2734036" cy="80609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D231E365-A3CD-1F44-99C5-E3AAA01DD057}"/>
              </a:ext>
            </a:extLst>
          </p:cNvPr>
          <p:cNvSpPr txBox="1"/>
          <p:nvPr/>
        </p:nvSpPr>
        <p:spPr>
          <a:xfrm>
            <a:off x="6994566" y="415636"/>
            <a:ext cx="2019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fferent exposures</a:t>
            </a:r>
          </a:p>
        </p:txBody>
      </p:sp>
    </p:spTree>
    <p:extLst>
      <p:ext uri="{BB962C8B-B14F-4D97-AF65-F5344CB8AC3E}">
        <p14:creationId xmlns:p14="http://schemas.microsoft.com/office/powerpoint/2010/main" val="33687517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2EBB293-1104-6440-B01D-FDBEF6CAE22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7924"/>
          <a:stretch/>
        </p:blipFill>
        <p:spPr>
          <a:xfrm>
            <a:off x="544374" y="705839"/>
            <a:ext cx="5381081" cy="289757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3ECC260-00AC-DB47-A11F-773A570464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7765814" y="200804"/>
            <a:ext cx="1655491" cy="2803653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28404C5-116A-F847-BCB8-8A113F604AC1}"/>
              </a:ext>
            </a:extLst>
          </p:cNvPr>
          <p:cNvCxnSpPr>
            <a:cxnSpLocks/>
          </p:cNvCxnSpPr>
          <p:nvPr/>
        </p:nvCxnSpPr>
        <p:spPr>
          <a:xfrm flipV="1">
            <a:off x="5257800" y="970581"/>
            <a:ext cx="2446020" cy="10068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851C2E4C-39A7-C842-923F-8E5825D192F8}"/>
              </a:ext>
            </a:extLst>
          </p:cNvPr>
          <p:cNvSpPr txBox="1"/>
          <p:nvPr/>
        </p:nvSpPr>
        <p:spPr>
          <a:xfrm>
            <a:off x="981571" y="109759"/>
            <a:ext cx="149188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Figure S2B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41DA9E39-6D50-6746-973D-FBDDC8D41171}"/>
              </a:ext>
            </a:extLst>
          </p:cNvPr>
          <p:cNvCxnSpPr>
            <a:cxnSpLocks/>
          </p:cNvCxnSpPr>
          <p:nvPr/>
        </p:nvCxnSpPr>
        <p:spPr>
          <a:xfrm>
            <a:off x="2793853" y="2502661"/>
            <a:ext cx="3597311" cy="29898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9">
            <a:extLst>
              <a:ext uri="{FF2B5EF4-FFF2-40B4-BE49-F238E27FC236}">
                <a16:creationId xmlns:a16="http://schemas.microsoft.com/office/drawing/2014/main" id="{C3F41E1B-04FF-984C-93E7-83369D6B68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80810" y="3667357"/>
            <a:ext cx="1728752" cy="29898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72390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4</Words>
  <Application>Microsoft Macintosh PowerPoint</Application>
  <PresentationFormat>Widescreen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mple Notani</dc:creator>
  <cp:lastModifiedBy>Sanjeev Galande</cp:lastModifiedBy>
  <cp:revision>9</cp:revision>
  <dcterms:created xsi:type="dcterms:W3CDTF">2021-12-03T09:05:02Z</dcterms:created>
  <dcterms:modified xsi:type="dcterms:W3CDTF">2021-12-18T13:32:31Z</dcterms:modified>
</cp:coreProperties>
</file>